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23A29-21BB-4D25-9E95-5ED1A7C0FB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DD4C35-8A2E-4D3B-A82B-FFA2E84974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D8AF8-1275-45A5-8FE0-5EF49AB1EF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69F65-1D7C-434E-BE30-06B4DDB6B8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008803-0DB5-4999-BF0C-FFC497D054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9A6C1-AFDD-4A00-8029-E17214114A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F08D3-7428-4662-846D-800D7EA629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3446B-9974-4773-BEE4-5A2B1F13A8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E3404-5933-4702-8D51-D9E365655B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E6325-41A4-4BAB-A223-629B05782E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7586A-C533-4054-A332-99CC362C01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3B1D2-5F51-4544-9C86-05D9F3975E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E87545-E375-454A-B559-E2C916F6EBFD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26"/>
          <p:cNvSpPr/>
          <p:nvPr/>
        </p:nvSpPr>
        <p:spPr>
          <a:xfrm>
            <a:off x="1125360" y="3979800"/>
            <a:ext cx="2519640" cy="78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18 patients got adequate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awake during ICU sta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(Assessment of MRC scor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feld 20"/>
          <p:cNvSpPr/>
          <p:nvPr/>
        </p:nvSpPr>
        <p:spPr>
          <a:xfrm>
            <a:off x="1773360" y="3208320"/>
            <a:ext cx="3095640" cy="533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Late skeletal muscle biops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(n=14; median day 16 (14/19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feld 9"/>
          <p:cNvSpPr/>
          <p:nvPr/>
        </p:nvSpPr>
        <p:spPr>
          <a:xfrm>
            <a:off x="1125360" y="1639800"/>
            <a:ext cx="3743640" cy="561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Early skeletal muscle biopsies from all patients (n=26; median day 6 (4/7)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feld 22"/>
          <p:cNvSpPr/>
          <p:nvPr/>
        </p:nvSpPr>
        <p:spPr>
          <a:xfrm>
            <a:off x="2133720" y="2440080"/>
            <a:ext cx="2735280" cy="531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7 patients discharged from ICU or died before 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MS ??"/>
              </a:rPr>
              <a:t>nd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 biops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4"/>
          <p:cNvSpPr/>
          <p:nvPr/>
        </p:nvSpPr>
        <p:spPr>
          <a:xfrm>
            <a:off x="1125360" y="5003640"/>
            <a:ext cx="3743640" cy="428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MS ??"/>
              </a:rPr>
              <a:t>Final analys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feld 6"/>
          <p:cNvSpPr/>
          <p:nvPr/>
        </p:nvSpPr>
        <p:spPr>
          <a:xfrm>
            <a:off x="1125360" y="1042920"/>
            <a:ext cx="3743640" cy="36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99"/>
              </a:spcBef>
              <a:spcAft>
                <a:spcPts val="4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??"/>
              </a:rPr>
              <a:t>26 ICU patients were included into stud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36"/>
          <p:cNvSpPr/>
          <p:nvPr/>
        </p:nvSpPr>
        <p:spPr>
          <a:xfrm>
            <a:off x="1916280" y="2257560"/>
            <a:ext cx="0" cy="8636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38"/>
          <p:cNvSpPr/>
          <p:nvPr/>
        </p:nvSpPr>
        <p:spPr>
          <a:xfrm>
            <a:off x="1555920" y="1414440"/>
            <a:ext cx="0" cy="21600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40"/>
          <p:cNvSpPr/>
          <p:nvPr/>
        </p:nvSpPr>
        <p:spPr>
          <a:xfrm>
            <a:off x="4149720" y="3805200"/>
            <a:ext cx="0" cy="11527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42"/>
          <p:cNvSpPr/>
          <p:nvPr/>
        </p:nvSpPr>
        <p:spPr>
          <a:xfrm>
            <a:off x="1555920" y="4813200"/>
            <a:ext cx="0" cy="14472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feld 2"/>
          <p:cNvSpPr/>
          <p:nvPr/>
        </p:nvSpPr>
        <p:spPr>
          <a:xfrm>
            <a:off x="210960" y="123840"/>
            <a:ext cx="2281320" cy="34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  <a:ea typeface="MS Mincho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44"/>
          <p:cNvSpPr/>
          <p:nvPr/>
        </p:nvSpPr>
        <p:spPr>
          <a:xfrm>
            <a:off x="2637000" y="3635280"/>
            <a:ext cx="1081080" cy="360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Overlap 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46"/>
          <p:cNvSpPr/>
          <p:nvPr/>
        </p:nvSpPr>
        <p:spPr>
          <a:xfrm>
            <a:off x="1917720" y="2689200"/>
            <a:ext cx="21600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47"/>
          <p:cNvSpPr/>
          <p:nvPr/>
        </p:nvSpPr>
        <p:spPr>
          <a:xfrm>
            <a:off x="1557360" y="2257560"/>
            <a:ext cx="0" cy="165564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10T10:54:40Z</dcterms:created>
  <dc:creator>jfielitz</dc:creator>
  <dc:description/>
  <dc:language>en-US</dc:language>
  <cp:lastModifiedBy>jfielitz</cp:lastModifiedBy>
  <dcterms:modified xsi:type="dcterms:W3CDTF">2014-07-07T14:05:48Z</dcterms:modified>
  <cp:revision>17</cp:revision>
  <dc:subject/>
  <dc:title>Folie 1</dc:title>
</cp:coreProperties>
</file>